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5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>
        <p:scale>
          <a:sx n="220" d="100"/>
          <a:sy n="220" d="100"/>
        </p:scale>
        <p:origin x="-9312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8BB7BD-2DED-4555-9D71-DA64C43952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5901689-0D81-41F9-B76B-6CEEE3109F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E29D67A-6DF4-482A-84AC-84F6E113E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BC581B8-D6CB-4C8A-973B-B1E58DE28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F7C58D-D95A-44FA-890D-236DC4549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1975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07E6B6-56BA-406E-A7C2-A2CB04B23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672A83D-65C0-493F-BED4-4795FAA131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456B5D4-57CE-47CC-8985-AEA7852EA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70BF97-41E6-4323-8D03-68700DDA8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289C1C-6B25-4CC8-81DA-60A62E952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8480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0A6BE4B-72F1-4B65-A147-CB88AF1F70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B0459A4-9687-411B-A752-767D69C891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B02F974-2B6A-4A04-9C3B-B0EB71DC5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1B1084-3A9E-4F07-81C3-351A30328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149FCB2-8DAE-40AE-8D58-89EC61440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18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9F71B4-3D9A-487F-995C-B9FC3CA7A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A5A05BE-0D14-46A9-BE0F-E5444522A8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B427DF-16E6-42E7-84B1-60A466382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26C9EDB-A4FB-4FB6-AAD0-B74B2F4F8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49A97A-5C0E-4501-A690-E43845A21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4809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98EF08F-67D6-4C73-81EC-6B36EF423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C44005B-C4AA-44A1-AE9C-76250222BE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A6C21E9-6751-4908-8C5C-A68CE712F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68C66D6-D935-4424-86ED-EE076536F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5633032-E432-4196-BBFE-BAC1A4F6E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6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4C60D1-8BF7-4D8F-846F-1F4A93FD0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64CF98B-DA7E-4860-A54F-15F1840B0B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68E2EDE-26F4-4ABA-8264-D8E3A00864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94A16E9-0A7E-4282-8422-B88F76198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87AAB93-A508-45DA-A246-6E557DB8D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1EAC2C5-9915-4C6B-8AD5-797A07B00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5492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D6752D-1FA4-48B5-AD61-9BFF2BEF7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3BEFD4D-7B24-4E70-BA5A-B64A9ED0DF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3558DE6-C76A-4727-B883-DDA878E6FF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08798BE-53FF-477A-BA6F-A9363D1A97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0AAF236-7B54-4F3E-AC4B-D421BF3F8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8B37F22-B37A-48CE-83E7-889916F3F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49F46C1-33D8-4F37-9C21-A521A2D39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7FE3D5D-8E5E-4856-8832-433B0C5B0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9660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2DABEAB-0E38-4934-8A45-E36D2E9FB0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FC099FD-547F-4C21-9483-EEA2679D3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226C94A-C533-4A17-9AF2-8B954B4E8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2A4EACD-7D7F-44B4-80FE-2937993D0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3732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3FE0F8A-B4BE-458E-80E3-5619F38D7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0287452-04AA-4B3A-B14F-F0BC879B7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26841F1-5EC0-4E4D-AB38-EC407E41D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5485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69F4C1-CCB8-4D98-B90E-4130CAA6F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ECDBF36-CC3E-499D-9943-47C652EF7D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D652765-7ADE-4145-B8CD-AD974E2546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17D7DD5-57CF-45CE-B5C2-FDA11CE2A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2F478D1-E2C9-4CDD-93E7-6CCC11EBF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AF5BD1A-80A0-4116-A99E-AC730EF6F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426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EB10EE-9244-4813-9070-217667DF1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0DB69D1-B299-486D-88E6-B48A3486AE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6DB4F82-9AF3-41DA-9012-9568D66B68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EC533B-F17D-46B4-940C-83A12C0D1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5E60A15-D9BD-4332-9779-A8F608D38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BB49435-50A1-4CBB-AB4C-2D615C009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1702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7D4CA96-8972-4216-8866-A3EC672E2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F3CB070-B8D0-4D10-8661-98BB37A14E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C847F7E-7735-4549-BB53-FCFE1FA598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A062F-AE85-47EE-8CBD-87258790F25B}" type="datetimeFigureOut">
              <a:rPr lang="it-IT" smtClean="0"/>
              <a:t>28/1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1CD096B-FE9F-43AE-9B53-5DCA8ECA79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E6DC410-B816-479E-8528-9B9C83466C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B0E35-7890-4208-9ED5-A225E5E129F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5043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26" Type="http://schemas.openxmlformats.org/officeDocument/2006/relationships/image" Target="../media/image15.png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5" Type="http://schemas.openxmlformats.org/officeDocument/2006/relationships/image" Target="../media/image14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10" Type="http://schemas.microsoft.com/office/2007/relationships/hdphoto" Target="../media/hdphoto4.wdp"/><Relationship Id="rId19" Type="http://schemas.openxmlformats.org/officeDocument/2006/relationships/image" Target="../media/image10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Relationship Id="rId22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CasellaDiTesto 229">
            <a:extLst>
              <a:ext uri="{FF2B5EF4-FFF2-40B4-BE49-F238E27FC236}">
                <a16:creationId xmlns:a16="http://schemas.microsoft.com/office/drawing/2014/main" id="{891C6CFA-4154-4D09-BA6D-91641F2B09E5}"/>
              </a:ext>
            </a:extLst>
          </p:cNvPr>
          <p:cNvSpPr txBox="1"/>
          <p:nvPr/>
        </p:nvSpPr>
        <p:spPr>
          <a:xfrm>
            <a:off x="5257685" y="1854062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3</a:t>
            </a:r>
          </a:p>
        </p:txBody>
      </p:sp>
      <p:grpSp>
        <p:nvGrpSpPr>
          <p:cNvPr id="89" name="Gruppo 88">
            <a:extLst>
              <a:ext uri="{FF2B5EF4-FFF2-40B4-BE49-F238E27FC236}">
                <a16:creationId xmlns:a16="http://schemas.microsoft.com/office/drawing/2014/main" id="{C9A79C9B-3293-4436-9131-0AED3CB0EF24}"/>
              </a:ext>
            </a:extLst>
          </p:cNvPr>
          <p:cNvGrpSpPr/>
          <p:nvPr/>
        </p:nvGrpSpPr>
        <p:grpSpPr>
          <a:xfrm>
            <a:off x="378054" y="260741"/>
            <a:ext cx="2377869" cy="1632324"/>
            <a:chOff x="679715" y="626035"/>
            <a:chExt cx="2177335" cy="1287375"/>
          </a:xfrm>
        </p:grpSpPr>
        <p:grpSp>
          <p:nvGrpSpPr>
            <p:cNvPr id="82" name="Gruppo 81">
              <a:extLst>
                <a:ext uri="{FF2B5EF4-FFF2-40B4-BE49-F238E27FC236}">
                  <a16:creationId xmlns:a16="http://schemas.microsoft.com/office/drawing/2014/main" id="{C5D82C64-9540-44D6-B286-B3F2F2D80C93}"/>
                </a:ext>
              </a:extLst>
            </p:cNvPr>
            <p:cNvGrpSpPr/>
            <p:nvPr/>
          </p:nvGrpSpPr>
          <p:grpSpPr>
            <a:xfrm>
              <a:off x="679715" y="626035"/>
              <a:ext cx="2177335" cy="1287375"/>
              <a:chOff x="679715" y="626035"/>
              <a:chExt cx="2177335" cy="1287375"/>
            </a:xfrm>
          </p:grpSpPr>
          <p:pic>
            <p:nvPicPr>
              <p:cNvPr id="3" name="Immagine 2">
                <a:extLst>
                  <a:ext uri="{FF2B5EF4-FFF2-40B4-BE49-F238E27FC236}">
                    <a16:creationId xmlns:a16="http://schemas.microsoft.com/office/drawing/2014/main" id="{D43DE70B-C8D5-4971-BCC2-7B55EA36BD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-50000"/>
                        </a14:imgEffect>
                        <a14:imgEffect>
                          <a14:brightnessContrast contrast="8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79715" y="822816"/>
                <a:ext cx="1705682" cy="1090594"/>
              </a:xfrm>
              <a:prstGeom prst="rect">
                <a:avLst/>
              </a:prstGeom>
            </p:spPr>
          </p:pic>
          <p:sp>
            <p:nvSpPr>
              <p:cNvPr id="8" name="CasellaDiTesto 100">
                <a:extLst>
                  <a:ext uri="{FF2B5EF4-FFF2-40B4-BE49-F238E27FC236}">
                    <a16:creationId xmlns:a16="http://schemas.microsoft.com/office/drawing/2014/main" id="{87B7928F-29AE-45A3-8B2D-969D6307122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99567" y="626035"/>
                <a:ext cx="5474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800" b="1" dirty="0">
                    <a:latin typeface="Palatino Linotype" panose="02040502050505030304" pitchFamily="18" charset="0"/>
                  </a:rPr>
                  <a:t>FGFR2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40780866-3883-43A4-86FA-C2D7BE750CA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32986" y="962106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C0D34C92-B086-4E23-8BC5-5990CD64C12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50183" y="1168649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135733AA-E784-4FF3-8571-CC65BA687A8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50183" y="1378582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75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7F7E7C0B-0EDF-44ED-A55C-CA9D0382203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43345" y="1728446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37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id="{DED0577B-0B5D-4138-BF84-87B749E1FA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43345" y="812982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5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0" name="Gruppo 89">
            <a:extLst>
              <a:ext uri="{FF2B5EF4-FFF2-40B4-BE49-F238E27FC236}">
                <a16:creationId xmlns:a16="http://schemas.microsoft.com/office/drawing/2014/main" id="{84D51570-1F06-41CF-83E3-5F1D298975EB}"/>
              </a:ext>
            </a:extLst>
          </p:cNvPr>
          <p:cNvGrpSpPr/>
          <p:nvPr/>
        </p:nvGrpSpPr>
        <p:grpSpPr>
          <a:xfrm>
            <a:off x="3394807" y="296945"/>
            <a:ext cx="1669410" cy="1189668"/>
            <a:chOff x="1224530" y="3046915"/>
            <a:chExt cx="1691711" cy="1299116"/>
          </a:xfrm>
        </p:grpSpPr>
        <p:grpSp>
          <p:nvGrpSpPr>
            <p:cNvPr id="81" name="Gruppo 80">
              <a:extLst>
                <a:ext uri="{FF2B5EF4-FFF2-40B4-BE49-F238E27FC236}">
                  <a16:creationId xmlns:a16="http://schemas.microsoft.com/office/drawing/2014/main" id="{8798A55F-7FC7-4658-8BB3-94F5E0A55021}"/>
                </a:ext>
              </a:extLst>
            </p:cNvPr>
            <p:cNvGrpSpPr/>
            <p:nvPr/>
          </p:nvGrpSpPr>
          <p:grpSpPr>
            <a:xfrm>
              <a:off x="1224530" y="3046915"/>
              <a:ext cx="1689610" cy="1299116"/>
              <a:chOff x="1354595" y="3046919"/>
              <a:chExt cx="1560068" cy="1238157"/>
            </a:xfrm>
          </p:grpSpPr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D1DC4B9E-A909-4895-BE39-D28993B58A2A}"/>
                  </a:ext>
                </a:extLst>
              </p:cNvPr>
              <p:cNvSpPr txBox="1"/>
              <p:nvPr/>
            </p:nvSpPr>
            <p:spPr>
              <a:xfrm>
                <a:off x="1354595" y="3046919"/>
                <a:ext cx="672347" cy="1720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Palatino Linotype" panose="02040502050505030304" pitchFamily="18" charset="0"/>
                  </a:rPr>
                  <a:t>p-FGFR2</a:t>
                </a:r>
              </a:p>
            </p:txBody>
          </p:sp>
          <p:grpSp>
            <p:nvGrpSpPr>
              <p:cNvPr id="73" name="Gruppo 72">
                <a:extLst>
                  <a:ext uri="{FF2B5EF4-FFF2-40B4-BE49-F238E27FC236}">
                    <a16:creationId xmlns:a16="http://schemas.microsoft.com/office/drawing/2014/main" id="{12E47131-13EC-4386-B658-00040F8B41A8}"/>
                  </a:ext>
                </a:extLst>
              </p:cNvPr>
              <p:cNvGrpSpPr/>
              <p:nvPr/>
            </p:nvGrpSpPr>
            <p:grpSpPr>
              <a:xfrm>
                <a:off x="2434697" y="3550211"/>
                <a:ext cx="479966" cy="734865"/>
                <a:chOff x="6494610" y="3490726"/>
                <a:chExt cx="526192" cy="769245"/>
              </a:xfrm>
            </p:grpSpPr>
            <p:sp>
              <p:nvSpPr>
                <p:cNvPr id="74" name="CasellaDiTesto 73">
                  <a:extLst>
                    <a:ext uri="{FF2B5EF4-FFF2-40B4-BE49-F238E27FC236}">
                      <a16:creationId xmlns:a16="http://schemas.microsoft.com/office/drawing/2014/main" id="{AD614E24-57F2-4FFE-B147-25164FDF667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94610" y="3490726"/>
                  <a:ext cx="526192" cy="201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5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CasellaDiTesto 74">
                  <a:extLst>
                    <a:ext uri="{FF2B5EF4-FFF2-40B4-BE49-F238E27FC236}">
                      <a16:creationId xmlns:a16="http://schemas.microsoft.com/office/drawing/2014/main" id="{A6817A5B-D748-461A-9CB1-DAF5993DBB6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04342" y="3842035"/>
                  <a:ext cx="485150" cy="201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CasellaDiTesto 75">
                  <a:extLst>
                    <a:ext uri="{FF2B5EF4-FFF2-40B4-BE49-F238E27FC236}">
                      <a16:creationId xmlns:a16="http://schemas.microsoft.com/office/drawing/2014/main" id="{A1C26892-CE98-41C6-8A1C-7E80DBA5990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08494" y="4075305"/>
                  <a:ext cx="5068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id="{E26F8382-C093-428E-87DB-0AD8E92C0A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09374" y="3317002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5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1" name="Gruppo 90">
            <a:extLst>
              <a:ext uri="{FF2B5EF4-FFF2-40B4-BE49-F238E27FC236}">
                <a16:creationId xmlns:a16="http://schemas.microsoft.com/office/drawing/2014/main" id="{91500E6E-62C4-4F61-B63D-704ACE5DA126}"/>
              </a:ext>
            </a:extLst>
          </p:cNvPr>
          <p:cNvGrpSpPr/>
          <p:nvPr/>
        </p:nvGrpSpPr>
        <p:grpSpPr>
          <a:xfrm>
            <a:off x="5905848" y="266604"/>
            <a:ext cx="1479563" cy="1029491"/>
            <a:chOff x="4943083" y="492975"/>
            <a:chExt cx="1479563" cy="1029491"/>
          </a:xfrm>
        </p:grpSpPr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24E1B90E-DD7C-44AA-8B66-EEBBD6620511}"/>
                </a:ext>
              </a:extLst>
            </p:cNvPr>
            <p:cNvSpPr/>
            <p:nvPr/>
          </p:nvSpPr>
          <p:spPr>
            <a:xfrm>
              <a:off x="4943083" y="492975"/>
              <a:ext cx="50045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800" b="1" dirty="0">
                  <a:latin typeface="Palatino Linotype" panose="02040502050505030304" pitchFamily="18" charset="0"/>
                </a:rPr>
                <a:t>FRS2</a:t>
              </a:r>
              <a:r>
                <a:rPr lang="el-GR" altLang="it-IT" sz="8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α</a:t>
              </a:r>
              <a:endParaRPr lang="it-IT" sz="800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53" name="Gruppo 52">
              <a:extLst>
                <a:ext uri="{FF2B5EF4-FFF2-40B4-BE49-F238E27FC236}">
                  <a16:creationId xmlns:a16="http://schemas.microsoft.com/office/drawing/2014/main" id="{399B33A0-E937-4C22-828C-2868E3C9843A}"/>
                </a:ext>
              </a:extLst>
            </p:cNvPr>
            <p:cNvGrpSpPr/>
            <p:nvPr/>
          </p:nvGrpSpPr>
          <p:grpSpPr>
            <a:xfrm>
              <a:off x="5898167" y="875767"/>
              <a:ext cx="524479" cy="646699"/>
              <a:chOff x="8983355" y="4158062"/>
              <a:chExt cx="524479" cy="646699"/>
            </a:xfrm>
          </p:grpSpPr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AE4B4A78-1437-4B72-8011-C980382D3A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000967" y="4158062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50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E336C4EF-6948-4DFA-8E17-5DCC82DCCED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996756" y="4408587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00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5D718023-4068-41C5-814F-0D5ED465937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983355" y="4620095"/>
                <a:ext cx="5068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75 </a:t>
                </a:r>
                <a:r>
                  <a:rPr lang="it-IT" altLang="it-IT" sz="600" dirty="0" err="1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kDa</a:t>
                </a:r>
                <a:endPara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id="{33794EB0-BA42-4B61-9696-8ECDEAC28D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11569" y="664259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5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Gruppo 91">
            <a:extLst>
              <a:ext uri="{FF2B5EF4-FFF2-40B4-BE49-F238E27FC236}">
                <a16:creationId xmlns:a16="http://schemas.microsoft.com/office/drawing/2014/main" id="{9178CD17-E129-4842-98DE-A3D188ADF7B0}"/>
              </a:ext>
            </a:extLst>
          </p:cNvPr>
          <p:cNvGrpSpPr/>
          <p:nvPr/>
        </p:nvGrpSpPr>
        <p:grpSpPr>
          <a:xfrm>
            <a:off x="8189786" y="311270"/>
            <a:ext cx="1671831" cy="996431"/>
            <a:chOff x="4833037" y="2070850"/>
            <a:chExt cx="1671831" cy="996431"/>
          </a:xfrm>
        </p:grpSpPr>
        <p:grpSp>
          <p:nvGrpSpPr>
            <p:cNvPr id="64" name="Gruppo 63">
              <a:extLst>
                <a:ext uri="{FF2B5EF4-FFF2-40B4-BE49-F238E27FC236}">
                  <a16:creationId xmlns:a16="http://schemas.microsoft.com/office/drawing/2014/main" id="{C40E84F4-9200-4528-A9A3-C253F48AED25}"/>
                </a:ext>
              </a:extLst>
            </p:cNvPr>
            <p:cNvGrpSpPr/>
            <p:nvPr/>
          </p:nvGrpSpPr>
          <p:grpSpPr>
            <a:xfrm>
              <a:off x="4833037" y="2070850"/>
              <a:ext cx="1631429" cy="996431"/>
              <a:chOff x="4833037" y="2070850"/>
              <a:chExt cx="1631429" cy="996431"/>
            </a:xfrm>
          </p:grpSpPr>
          <p:grpSp>
            <p:nvGrpSpPr>
              <p:cNvPr id="31" name="Gruppo 30">
                <a:extLst>
                  <a:ext uri="{FF2B5EF4-FFF2-40B4-BE49-F238E27FC236}">
                    <a16:creationId xmlns:a16="http://schemas.microsoft.com/office/drawing/2014/main" id="{172F4217-38B5-4422-A16E-73518184B0AA}"/>
                  </a:ext>
                </a:extLst>
              </p:cNvPr>
              <p:cNvGrpSpPr/>
              <p:nvPr/>
            </p:nvGrpSpPr>
            <p:grpSpPr>
              <a:xfrm>
                <a:off x="5998001" y="2433413"/>
                <a:ext cx="466465" cy="633868"/>
                <a:chOff x="6516331" y="3536580"/>
                <a:chExt cx="511391" cy="663524"/>
              </a:xfrm>
            </p:grpSpPr>
            <p:sp>
              <p:nvSpPr>
                <p:cNvPr id="21" name="CasellaDiTesto 20">
                  <a:extLst>
                    <a:ext uri="{FF2B5EF4-FFF2-40B4-BE49-F238E27FC236}">
                      <a16:creationId xmlns:a16="http://schemas.microsoft.com/office/drawing/2014/main" id="{CEB85040-5A08-4BC7-A671-2CF5A006A3C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20855" y="3536580"/>
                  <a:ext cx="5068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5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CasellaDiTesto 21">
                  <a:extLst>
                    <a:ext uri="{FF2B5EF4-FFF2-40B4-BE49-F238E27FC236}">
                      <a16:creationId xmlns:a16="http://schemas.microsoft.com/office/drawing/2014/main" id="{8EB7B0E1-8791-4F0F-9707-971F12B361E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16331" y="3795086"/>
                  <a:ext cx="5068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CasellaDiTesto 22">
                  <a:extLst>
                    <a:ext uri="{FF2B5EF4-FFF2-40B4-BE49-F238E27FC236}">
                      <a16:creationId xmlns:a16="http://schemas.microsoft.com/office/drawing/2014/main" id="{6B1DC427-F89B-4A64-9333-1C7D94516E5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16331" y="4015438"/>
                  <a:ext cx="506867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0" name="Rettangolo 39">
                <a:extLst>
                  <a:ext uri="{FF2B5EF4-FFF2-40B4-BE49-F238E27FC236}">
                    <a16:creationId xmlns:a16="http://schemas.microsoft.com/office/drawing/2014/main" id="{81729FFB-0E56-46ED-9647-7C006B77EA67}"/>
                  </a:ext>
                </a:extLst>
              </p:cNvPr>
              <p:cNvSpPr/>
              <p:nvPr/>
            </p:nvSpPr>
            <p:spPr>
              <a:xfrm>
                <a:off x="4833037" y="2070850"/>
                <a:ext cx="59663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800" b="1" dirty="0">
                    <a:latin typeface="Palatino Linotype" panose="02040502050505030304" pitchFamily="18" charset="0"/>
                  </a:rPr>
                  <a:t>p-FRS2</a:t>
                </a:r>
                <a:r>
                  <a:rPr lang="el-GR" altLang="it-IT" sz="800" b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α</a:t>
                </a:r>
                <a:endParaRPr lang="it-IT" sz="800" dirty="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id="{E12BD870-91C0-4A37-97EE-7EB72D65B7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98001" y="2233132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5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9" name="Gruppo 58">
            <a:extLst>
              <a:ext uri="{FF2B5EF4-FFF2-40B4-BE49-F238E27FC236}">
                <a16:creationId xmlns:a16="http://schemas.microsoft.com/office/drawing/2014/main" id="{6122B306-C45D-46B0-955B-0184198C314E}"/>
              </a:ext>
            </a:extLst>
          </p:cNvPr>
          <p:cNvGrpSpPr/>
          <p:nvPr/>
        </p:nvGrpSpPr>
        <p:grpSpPr>
          <a:xfrm>
            <a:off x="11651716" y="635506"/>
            <a:ext cx="466465" cy="1043619"/>
            <a:chOff x="6516331" y="3536580"/>
            <a:chExt cx="511391" cy="1092445"/>
          </a:xfrm>
        </p:grpSpPr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639B0F29-5192-42A3-99C2-D2D84FF977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20855" y="3536580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5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67F2923A-DED5-4897-9026-DA5553EE12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6331" y="3795086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100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789AA096-4C69-40C5-8AB6-585AFD77D8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6331" y="4015438"/>
              <a:ext cx="5068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75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EBA94BB4-C14A-41C1-BA16-64F61226E0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6331" y="4444360"/>
              <a:ext cx="506867" cy="184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it-IT" sz="600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37 </a:t>
              </a:r>
              <a:r>
                <a:rPr lang="it-IT" altLang="it-IT" sz="600" dirty="0" err="1">
                  <a:latin typeface="Palatino Linotype" panose="02040502050505030304" pitchFamily="18" charset="0"/>
                  <a:cs typeface="Times New Roman" panose="02020603050405020304" pitchFamily="18" charset="0"/>
                </a:rPr>
                <a:t>kDa</a:t>
              </a:r>
              <a:endPara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F3B69542-8C32-4700-8625-3F4FCEF6F9C9}"/>
              </a:ext>
            </a:extLst>
          </p:cNvPr>
          <p:cNvSpPr txBox="1"/>
          <p:nvPr/>
        </p:nvSpPr>
        <p:spPr>
          <a:xfrm>
            <a:off x="10381009" y="266604"/>
            <a:ext cx="951239" cy="204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Palatino Linotype" panose="02040502050505030304" pitchFamily="18" charset="0"/>
              </a:rPr>
              <a:t>GADPH</a:t>
            </a: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A421C8A0-9079-434B-8DD9-033D5733A8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51716" y="459678"/>
            <a:ext cx="50686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250 </a:t>
            </a:r>
            <a:r>
              <a:rPr lang="it-IT" altLang="it-IT" sz="6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Rettangolo 230">
            <a:extLst>
              <a:ext uri="{FF2B5EF4-FFF2-40B4-BE49-F238E27FC236}">
                <a16:creationId xmlns:a16="http://schemas.microsoft.com/office/drawing/2014/main" id="{509351FD-5630-42AC-B71F-8F1D7BE60514}"/>
              </a:ext>
            </a:extLst>
          </p:cNvPr>
          <p:cNvSpPr/>
          <p:nvPr/>
        </p:nvSpPr>
        <p:spPr>
          <a:xfrm>
            <a:off x="238125" y="204050"/>
            <a:ext cx="11830050" cy="2235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37" name="Gruppo 236">
            <a:extLst>
              <a:ext uri="{FF2B5EF4-FFF2-40B4-BE49-F238E27FC236}">
                <a16:creationId xmlns:a16="http://schemas.microsoft.com/office/drawing/2014/main" id="{B099D09B-E1EF-491F-88CC-06C643D43E23}"/>
              </a:ext>
            </a:extLst>
          </p:cNvPr>
          <p:cNvGrpSpPr/>
          <p:nvPr/>
        </p:nvGrpSpPr>
        <p:grpSpPr>
          <a:xfrm>
            <a:off x="238125" y="2543175"/>
            <a:ext cx="11582400" cy="2169172"/>
            <a:chOff x="238125" y="2543175"/>
            <a:chExt cx="11582400" cy="2169172"/>
          </a:xfrm>
        </p:grpSpPr>
        <p:grpSp>
          <p:nvGrpSpPr>
            <p:cNvPr id="228" name="Gruppo 227">
              <a:extLst>
                <a:ext uri="{FF2B5EF4-FFF2-40B4-BE49-F238E27FC236}">
                  <a16:creationId xmlns:a16="http://schemas.microsoft.com/office/drawing/2014/main" id="{517EB801-7FA9-4E8A-A7E5-8528DD15AD3F}"/>
                </a:ext>
              </a:extLst>
            </p:cNvPr>
            <p:cNvGrpSpPr/>
            <p:nvPr/>
          </p:nvGrpSpPr>
          <p:grpSpPr>
            <a:xfrm>
              <a:off x="1119380" y="2658197"/>
              <a:ext cx="9052013" cy="1901107"/>
              <a:chOff x="946220" y="2592071"/>
              <a:chExt cx="9052013" cy="1901107"/>
            </a:xfrm>
          </p:grpSpPr>
          <p:grpSp>
            <p:nvGrpSpPr>
              <p:cNvPr id="143" name="Gruppo 142">
                <a:extLst>
                  <a:ext uri="{FF2B5EF4-FFF2-40B4-BE49-F238E27FC236}">
                    <a16:creationId xmlns:a16="http://schemas.microsoft.com/office/drawing/2014/main" id="{2C330FF3-0E10-4A1D-BD6B-15CCAECFEF18}"/>
                  </a:ext>
                </a:extLst>
              </p:cNvPr>
              <p:cNvGrpSpPr/>
              <p:nvPr/>
            </p:nvGrpSpPr>
            <p:grpSpPr>
              <a:xfrm>
                <a:off x="946220" y="2592071"/>
                <a:ext cx="1685738" cy="1850891"/>
                <a:chOff x="9249702" y="706550"/>
                <a:chExt cx="1685738" cy="1734523"/>
              </a:xfrm>
            </p:grpSpPr>
            <p:grpSp>
              <p:nvGrpSpPr>
                <p:cNvPr id="128" name="Gruppo 127">
                  <a:extLst>
                    <a:ext uri="{FF2B5EF4-FFF2-40B4-BE49-F238E27FC236}">
                      <a16:creationId xmlns:a16="http://schemas.microsoft.com/office/drawing/2014/main" id="{62467BE3-C354-4559-A336-077B460D972C}"/>
                    </a:ext>
                  </a:extLst>
                </p:cNvPr>
                <p:cNvGrpSpPr/>
                <p:nvPr/>
              </p:nvGrpSpPr>
              <p:grpSpPr>
                <a:xfrm>
                  <a:off x="9249702" y="894952"/>
                  <a:ext cx="1685738" cy="1546121"/>
                  <a:chOff x="9097413" y="1371029"/>
                  <a:chExt cx="1685738" cy="1432022"/>
                </a:xfrm>
              </p:grpSpPr>
              <p:pic>
                <p:nvPicPr>
                  <p:cNvPr id="122" name="Immagine 121">
                    <a:extLst>
                      <a:ext uri="{FF2B5EF4-FFF2-40B4-BE49-F238E27FC236}">
                        <a16:creationId xmlns:a16="http://schemas.microsoft.com/office/drawing/2014/main" id="{0CF843CE-9E60-4E43-85DA-F7A551B5A3D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-50000"/>
                            </a14:imgEffect>
                            <a14:imgEffect>
                              <a14:brightnessContrast bright="-18000" contrast="4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532661" y="1405822"/>
                    <a:ext cx="1250490" cy="1397229"/>
                  </a:xfrm>
                  <a:prstGeom prst="rect">
                    <a:avLst/>
                  </a:prstGeom>
                </p:spPr>
              </p:pic>
              <p:sp>
                <p:nvSpPr>
                  <p:cNvPr id="123" name="CasellaDiTesto 122">
                    <a:extLst>
                      <a:ext uri="{FF2B5EF4-FFF2-40B4-BE49-F238E27FC236}">
                        <a16:creationId xmlns:a16="http://schemas.microsoft.com/office/drawing/2014/main" id="{D4A628BA-36F5-41E8-8787-8FE4AF7A8374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13650" y="1371029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2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4" name="CasellaDiTesto 123">
                    <a:extLst>
                      <a:ext uri="{FF2B5EF4-FFF2-40B4-BE49-F238E27FC236}">
                        <a16:creationId xmlns:a16="http://schemas.microsoft.com/office/drawing/2014/main" id="{D08B89A2-9BA6-457A-93C9-C4208262E10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04787" y="1576548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5" name="CasellaDiTesto 124">
                    <a:extLst>
                      <a:ext uri="{FF2B5EF4-FFF2-40B4-BE49-F238E27FC236}">
                        <a16:creationId xmlns:a16="http://schemas.microsoft.com/office/drawing/2014/main" id="{C72769A2-997F-4B3F-B486-E7F635E3B2E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097413" y="1869584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6" name="CasellaDiTesto 125">
                    <a:extLst>
                      <a:ext uri="{FF2B5EF4-FFF2-40B4-BE49-F238E27FC236}">
                        <a16:creationId xmlns:a16="http://schemas.microsoft.com/office/drawing/2014/main" id="{FBEFA054-055A-4C33-A4EA-481E36F9ABF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13649" y="2063914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7" name="CasellaDiTesto 126">
                    <a:extLst>
                      <a:ext uri="{FF2B5EF4-FFF2-40B4-BE49-F238E27FC236}">
                        <a16:creationId xmlns:a16="http://schemas.microsoft.com/office/drawing/2014/main" id="{8668BFCC-091F-4C44-9AF6-FFE43EB77BCA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13649" y="2596758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40" name="CasellaDiTesto 100">
                  <a:extLst>
                    <a:ext uri="{FF2B5EF4-FFF2-40B4-BE49-F238E27FC236}">
                      <a16:creationId xmlns:a16="http://schemas.microsoft.com/office/drawing/2014/main" id="{F9B0195F-B8E5-4BB6-A032-357F021EDD9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0036491" y="706550"/>
                  <a:ext cx="547407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800" b="1" dirty="0">
                      <a:latin typeface="Palatino Linotype" panose="02040502050505030304" pitchFamily="18" charset="0"/>
                    </a:rPr>
                    <a:t>FGFR2</a:t>
                  </a:r>
                </a:p>
              </p:txBody>
            </p:sp>
          </p:grpSp>
          <p:grpSp>
            <p:nvGrpSpPr>
              <p:cNvPr id="142" name="Gruppo 141">
                <a:extLst>
                  <a:ext uri="{FF2B5EF4-FFF2-40B4-BE49-F238E27FC236}">
                    <a16:creationId xmlns:a16="http://schemas.microsoft.com/office/drawing/2014/main" id="{EEB3AE0B-AC01-4091-AE0F-21B839289AFB}"/>
                  </a:ext>
                </a:extLst>
              </p:cNvPr>
              <p:cNvGrpSpPr/>
              <p:nvPr/>
            </p:nvGrpSpPr>
            <p:grpSpPr>
              <a:xfrm>
                <a:off x="2801741" y="2630444"/>
                <a:ext cx="1448068" cy="1862734"/>
                <a:chOff x="9226214" y="2555953"/>
                <a:chExt cx="1448068" cy="1745622"/>
              </a:xfrm>
            </p:grpSpPr>
            <p:grpSp>
              <p:nvGrpSpPr>
                <p:cNvPr id="138" name="Gruppo 137">
                  <a:extLst>
                    <a:ext uri="{FF2B5EF4-FFF2-40B4-BE49-F238E27FC236}">
                      <a16:creationId xmlns:a16="http://schemas.microsoft.com/office/drawing/2014/main" id="{BC8E8649-8E69-4446-A0CC-8007E0CFA75F}"/>
                    </a:ext>
                  </a:extLst>
                </p:cNvPr>
                <p:cNvGrpSpPr/>
                <p:nvPr/>
              </p:nvGrpSpPr>
              <p:grpSpPr>
                <a:xfrm>
                  <a:off x="9226214" y="2769953"/>
                  <a:ext cx="546590" cy="1531622"/>
                  <a:chOff x="9226214" y="2769953"/>
                  <a:chExt cx="546590" cy="1531622"/>
                </a:xfrm>
              </p:grpSpPr>
              <p:sp>
                <p:nvSpPr>
                  <p:cNvPr id="133" name="CasellaDiTesto 132">
                    <a:extLst>
                      <a:ext uri="{FF2B5EF4-FFF2-40B4-BE49-F238E27FC236}">
                        <a16:creationId xmlns:a16="http://schemas.microsoft.com/office/drawing/2014/main" id="{4622EE9D-88A4-4F1C-8750-0F139453537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26215" y="2976442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4" name="CasellaDiTesto 133">
                    <a:extLst>
                      <a:ext uri="{FF2B5EF4-FFF2-40B4-BE49-F238E27FC236}">
                        <a16:creationId xmlns:a16="http://schemas.microsoft.com/office/drawing/2014/main" id="{99FAF0DE-7E47-4BCF-A4AA-0DF89B53B5A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57075" y="4102195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5" name="CasellaDiTesto 134">
                    <a:extLst>
                      <a:ext uri="{FF2B5EF4-FFF2-40B4-BE49-F238E27FC236}">
                        <a16:creationId xmlns:a16="http://schemas.microsoft.com/office/drawing/2014/main" id="{F6B0B6CF-F692-475F-891F-87A93678177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65937" y="3517121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6" name="CasellaDiTesto 135">
                    <a:extLst>
                      <a:ext uri="{FF2B5EF4-FFF2-40B4-BE49-F238E27FC236}">
                        <a16:creationId xmlns:a16="http://schemas.microsoft.com/office/drawing/2014/main" id="{729809CD-4C1D-4915-ACF5-546F11F1C35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40900" y="3287565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7" name="CasellaDiTesto 136">
                    <a:extLst>
                      <a:ext uri="{FF2B5EF4-FFF2-40B4-BE49-F238E27FC236}">
                        <a16:creationId xmlns:a16="http://schemas.microsoft.com/office/drawing/2014/main" id="{4B2840FB-F926-41C1-A09E-A49B476B5E4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26214" y="2769953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2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41" name="CasellaDiTesto 140">
                  <a:extLst>
                    <a:ext uri="{FF2B5EF4-FFF2-40B4-BE49-F238E27FC236}">
                      <a16:creationId xmlns:a16="http://schemas.microsoft.com/office/drawing/2014/main" id="{2DDF2DFA-E28E-4B0D-B1F5-2BFB52168AD3}"/>
                    </a:ext>
                  </a:extLst>
                </p:cNvPr>
                <p:cNvSpPr txBox="1"/>
                <p:nvPr/>
              </p:nvSpPr>
              <p:spPr>
                <a:xfrm>
                  <a:off x="9946106" y="2555953"/>
                  <a:ext cx="728176" cy="1805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p-FGFR2</a:t>
                  </a:r>
                </a:p>
              </p:txBody>
            </p:sp>
          </p:grpSp>
          <p:grpSp>
            <p:nvGrpSpPr>
              <p:cNvPr id="163" name="Gruppo 162">
                <a:extLst>
                  <a:ext uri="{FF2B5EF4-FFF2-40B4-BE49-F238E27FC236}">
                    <a16:creationId xmlns:a16="http://schemas.microsoft.com/office/drawing/2014/main" id="{6DA00335-08EA-44C1-8432-B4B54FB3B9E9}"/>
                  </a:ext>
                </a:extLst>
              </p:cNvPr>
              <p:cNvGrpSpPr/>
              <p:nvPr/>
            </p:nvGrpSpPr>
            <p:grpSpPr>
              <a:xfrm>
                <a:off x="6499079" y="2614294"/>
                <a:ext cx="1791974" cy="1832560"/>
                <a:chOff x="10068870" y="3910087"/>
                <a:chExt cx="1944212" cy="1960034"/>
              </a:xfrm>
            </p:grpSpPr>
            <p:pic>
              <p:nvPicPr>
                <p:cNvPr id="146" name="Immagine 145">
                  <a:extLst>
                    <a:ext uri="{FF2B5EF4-FFF2-40B4-BE49-F238E27FC236}">
                      <a16:creationId xmlns:a16="http://schemas.microsoft.com/office/drawing/2014/main" id="{7D001902-787F-4AF8-8854-32ED1D4E2A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-60000"/>
                          </a14:imgEffect>
                          <a14:imgEffect>
                            <a14:brightnessContrast contrast="32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528501" y="4123825"/>
                  <a:ext cx="1379249" cy="1746296"/>
                </a:xfrm>
                <a:prstGeom prst="rect">
                  <a:avLst/>
                </a:prstGeom>
              </p:spPr>
            </p:pic>
            <p:sp>
              <p:nvSpPr>
                <p:cNvPr id="148" name="CasellaDiTesto 147">
                  <a:extLst>
                    <a:ext uri="{FF2B5EF4-FFF2-40B4-BE49-F238E27FC236}">
                      <a16:creationId xmlns:a16="http://schemas.microsoft.com/office/drawing/2014/main" id="{1CFB137B-5128-4AC2-9064-BAA95AA6C97E}"/>
                    </a:ext>
                  </a:extLst>
                </p:cNvPr>
                <p:cNvSpPr txBox="1"/>
                <p:nvPr/>
              </p:nvSpPr>
              <p:spPr>
                <a:xfrm>
                  <a:off x="10884923" y="3910087"/>
                  <a:ext cx="11281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p-FRS2</a:t>
                  </a:r>
                  <a:r>
                    <a:rPr lang="el-GR" altLang="it-IT" sz="8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α</a:t>
                  </a:r>
                  <a:endParaRPr lang="it-IT" sz="800" b="1" dirty="0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156" name="Gruppo 155">
                  <a:extLst>
                    <a:ext uri="{FF2B5EF4-FFF2-40B4-BE49-F238E27FC236}">
                      <a16:creationId xmlns:a16="http://schemas.microsoft.com/office/drawing/2014/main" id="{618F27DA-5F18-4907-8476-CAAC160E2A2A}"/>
                    </a:ext>
                  </a:extLst>
                </p:cNvPr>
                <p:cNvGrpSpPr/>
                <p:nvPr/>
              </p:nvGrpSpPr>
              <p:grpSpPr>
                <a:xfrm>
                  <a:off x="10068870" y="4086405"/>
                  <a:ext cx="557568" cy="1770535"/>
                  <a:chOff x="8597939" y="4100466"/>
                  <a:chExt cx="557568" cy="1770535"/>
                </a:xfrm>
              </p:grpSpPr>
              <p:sp>
                <p:nvSpPr>
                  <p:cNvPr id="157" name="CasellaDiTesto 156">
                    <a:extLst>
                      <a:ext uri="{FF2B5EF4-FFF2-40B4-BE49-F238E27FC236}">
                        <a16:creationId xmlns:a16="http://schemas.microsoft.com/office/drawing/2014/main" id="{5F179979-F205-4DAB-B6D4-19F9A4BE73D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97939" y="4100466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2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8" name="CasellaDiTesto 157">
                    <a:extLst>
                      <a:ext uri="{FF2B5EF4-FFF2-40B4-BE49-F238E27FC236}">
                        <a16:creationId xmlns:a16="http://schemas.microsoft.com/office/drawing/2014/main" id="{F6435ACF-C564-4E69-B9F4-0B6672EC3A9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14379" y="4373421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9" name="CasellaDiTesto 158">
                    <a:extLst>
                      <a:ext uri="{FF2B5EF4-FFF2-40B4-BE49-F238E27FC236}">
                        <a16:creationId xmlns:a16="http://schemas.microsoft.com/office/drawing/2014/main" id="{59E878F6-1074-4F06-82AC-40C5F3D78C8D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14379" y="4761646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0" name="CasellaDiTesto 159">
                    <a:extLst>
                      <a:ext uri="{FF2B5EF4-FFF2-40B4-BE49-F238E27FC236}">
                        <a16:creationId xmlns:a16="http://schemas.microsoft.com/office/drawing/2014/main" id="{F08B5AB4-9607-4E9C-A69A-870C88C9CF8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30566" y="5014841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1" name="CasellaDiTesto 160">
                    <a:extLst>
                      <a:ext uri="{FF2B5EF4-FFF2-40B4-BE49-F238E27FC236}">
                        <a16:creationId xmlns:a16="http://schemas.microsoft.com/office/drawing/2014/main" id="{E4840418-7CB0-444C-853A-4259AFAF80A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48640" y="5671621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174" name="Gruppo 173">
                <a:extLst>
                  <a:ext uri="{FF2B5EF4-FFF2-40B4-BE49-F238E27FC236}">
                    <a16:creationId xmlns:a16="http://schemas.microsoft.com/office/drawing/2014/main" id="{76C5A2B7-E950-4FF7-837E-AD207C794227}"/>
                  </a:ext>
                </a:extLst>
              </p:cNvPr>
              <p:cNvGrpSpPr/>
              <p:nvPr/>
            </p:nvGrpSpPr>
            <p:grpSpPr>
              <a:xfrm>
                <a:off x="8298065" y="2592071"/>
                <a:ext cx="1700168" cy="1777443"/>
                <a:chOff x="9717310" y="3762356"/>
                <a:chExt cx="1700168" cy="1713951"/>
              </a:xfrm>
            </p:grpSpPr>
            <p:sp>
              <p:nvSpPr>
                <p:cNvPr id="168" name="CasellaDiTesto 167">
                  <a:extLst>
                    <a:ext uri="{FF2B5EF4-FFF2-40B4-BE49-F238E27FC236}">
                      <a16:creationId xmlns:a16="http://schemas.microsoft.com/office/drawing/2014/main" id="{FD82C78D-9494-42D7-8E02-EA6E016736B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733875" y="4178233"/>
                  <a:ext cx="467178" cy="1726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5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9" name="CasellaDiTesto 168">
                  <a:extLst>
                    <a:ext uri="{FF2B5EF4-FFF2-40B4-BE49-F238E27FC236}">
                      <a16:creationId xmlns:a16="http://schemas.microsoft.com/office/drawing/2014/main" id="{006F8E82-6D60-4D46-916D-0EEE678AA1D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730620" y="3931281"/>
                  <a:ext cx="467178" cy="1726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25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0" name="CasellaDiTesto 169">
                  <a:extLst>
                    <a:ext uri="{FF2B5EF4-FFF2-40B4-BE49-F238E27FC236}">
                      <a16:creationId xmlns:a16="http://schemas.microsoft.com/office/drawing/2014/main" id="{2B9DDB10-5FAC-4043-95A6-B142A0310C1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717310" y="4475065"/>
                  <a:ext cx="467178" cy="1726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1" name="CasellaDiTesto 170">
                  <a:extLst>
                    <a:ext uri="{FF2B5EF4-FFF2-40B4-BE49-F238E27FC236}">
                      <a16:creationId xmlns:a16="http://schemas.microsoft.com/office/drawing/2014/main" id="{1D70689B-E3A6-4038-9423-D5E6262D2FF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761715" y="4723882"/>
                  <a:ext cx="467178" cy="1864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CasellaDiTesto 171">
                  <a:extLst>
                    <a:ext uri="{FF2B5EF4-FFF2-40B4-BE49-F238E27FC236}">
                      <a16:creationId xmlns:a16="http://schemas.microsoft.com/office/drawing/2014/main" id="{6FB97CB1-BD4A-459D-837A-66E5D51EE83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9772712" y="5289894"/>
                  <a:ext cx="467178" cy="1864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CasellaDiTesto 172">
                  <a:extLst>
                    <a:ext uri="{FF2B5EF4-FFF2-40B4-BE49-F238E27FC236}">
                      <a16:creationId xmlns:a16="http://schemas.microsoft.com/office/drawing/2014/main" id="{C68AA668-9C0C-4EA9-A9A7-D9B521E262DE}"/>
                    </a:ext>
                  </a:extLst>
                </p:cNvPr>
                <p:cNvSpPr txBox="1"/>
                <p:nvPr/>
              </p:nvSpPr>
              <p:spPr>
                <a:xfrm>
                  <a:off x="10466239" y="3762356"/>
                  <a:ext cx="951239" cy="2043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GADPH</a:t>
                  </a:r>
                </a:p>
              </p:txBody>
            </p:sp>
          </p:grpSp>
          <p:grpSp>
            <p:nvGrpSpPr>
              <p:cNvPr id="162" name="Gruppo 161">
                <a:extLst>
                  <a:ext uri="{FF2B5EF4-FFF2-40B4-BE49-F238E27FC236}">
                    <a16:creationId xmlns:a16="http://schemas.microsoft.com/office/drawing/2014/main" id="{32CABA48-14C7-4F70-9733-DA379B79D839}"/>
                  </a:ext>
                </a:extLst>
              </p:cNvPr>
              <p:cNvGrpSpPr/>
              <p:nvPr/>
            </p:nvGrpSpPr>
            <p:grpSpPr>
              <a:xfrm>
                <a:off x="4639871" y="2610298"/>
                <a:ext cx="1810223" cy="1832023"/>
                <a:chOff x="8597939" y="3879474"/>
                <a:chExt cx="1964011" cy="1959462"/>
              </a:xfrm>
            </p:grpSpPr>
            <p:sp>
              <p:nvSpPr>
                <p:cNvPr id="147" name="CasellaDiTesto 146">
                  <a:extLst>
                    <a:ext uri="{FF2B5EF4-FFF2-40B4-BE49-F238E27FC236}">
                      <a16:creationId xmlns:a16="http://schemas.microsoft.com/office/drawing/2014/main" id="{95FE762D-D6C1-47CE-82B6-8598BAB4E013}"/>
                    </a:ext>
                  </a:extLst>
                </p:cNvPr>
                <p:cNvSpPr txBox="1"/>
                <p:nvPr/>
              </p:nvSpPr>
              <p:spPr>
                <a:xfrm>
                  <a:off x="9433791" y="3879474"/>
                  <a:ext cx="11281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FRS2</a:t>
                  </a:r>
                  <a:r>
                    <a:rPr lang="el-GR" altLang="it-IT" sz="8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α</a:t>
                  </a:r>
                  <a:endParaRPr lang="it-IT" sz="800" b="1" dirty="0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155" name="Gruppo 154">
                  <a:extLst>
                    <a:ext uri="{FF2B5EF4-FFF2-40B4-BE49-F238E27FC236}">
                      <a16:creationId xmlns:a16="http://schemas.microsoft.com/office/drawing/2014/main" id="{DC475320-C223-4E74-A83A-1A77280C1789}"/>
                    </a:ext>
                  </a:extLst>
                </p:cNvPr>
                <p:cNvGrpSpPr/>
                <p:nvPr/>
              </p:nvGrpSpPr>
              <p:grpSpPr>
                <a:xfrm>
                  <a:off x="8597939" y="4100466"/>
                  <a:ext cx="557568" cy="1738470"/>
                  <a:chOff x="8597939" y="4100466"/>
                  <a:chExt cx="557568" cy="1738470"/>
                </a:xfrm>
              </p:grpSpPr>
              <p:sp>
                <p:nvSpPr>
                  <p:cNvPr id="150" name="CasellaDiTesto 149">
                    <a:extLst>
                      <a:ext uri="{FF2B5EF4-FFF2-40B4-BE49-F238E27FC236}">
                        <a16:creationId xmlns:a16="http://schemas.microsoft.com/office/drawing/2014/main" id="{BD313C7C-C1CC-403B-A225-803E74F884A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97939" y="4100466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2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1" name="CasellaDiTesto 150">
                    <a:extLst>
                      <a:ext uri="{FF2B5EF4-FFF2-40B4-BE49-F238E27FC236}">
                        <a16:creationId xmlns:a16="http://schemas.microsoft.com/office/drawing/2014/main" id="{9B8FED49-B8DF-412F-862B-0FA580EDF6E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14379" y="4373421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2" name="CasellaDiTesto 151">
                    <a:extLst>
                      <a:ext uri="{FF2B5EF4-FFF2-40B4-BE49-F238E27FC236}">
                        <a16:creationId xmlns:a16="http://schemas.microsoft.com/office/drawing/2014/main" id="{652A9CE3-B78C-4C78-A3F5-D427889385C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14379" y="4761646"/>
                    <a:ext cx="506867" cy="18466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3" name="CasellaDiTesto 152">
                    <a:extLst>
                      <a:ext uri="{FF2B5EF4-FFF2-40B4-BE49-F238E27FC236}">
                        <a16:creationId xmlns:a16="http://schemas.microsoft.com/office/drawing/2014/main" id="{1DE90BF3-FF7F-4F03-9028-E460980C101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30566" y="5014841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4" name="CasellaDiTesto 153">
                    <a:extLst>
                      <a:ext uri="{FF2B5EF4-FFF2-40B4-BE49-F238E27FC236}">
                        <a16:creationId xmlns:a16="http://schemas.microsoft.com/office/drawing/2014/main" id="{9946EFDD-9092-47A5-8F94-C703C5578E8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48640" y="5639556"/>
                    <a:ext cx="506867" cy="19938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234" name="CasellaDiTesto 233">
              <a:extLst>
                <a:ext uri="{FF2B5EF4-FFF2-40B4-BE49-F238E27FC236}">
                  <a16:creationId xmlns:a16="http://schemas.microsoft.com/office/drawing/2014/main" id="{F89025E7-FD0E-4A78-A8A0-FE9EE7C66180}"/>
                </a:ext>
              </a:extLst>
            </p:cNvPr>
            <p:cNvSpPr txBox="1"/>
            <p:nvPr/>
          </p:nvSpPr>
          <p:spPr>
            <a:xfrm>
              <a:off x="10395581" y="3499674"/>
              <a:ext cx="9366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Figure 4</a:t>
              </a:r>
            </a:p>
          </p:txBody>
        </p:sp>
        <p:sp>
          <p:nvSpPr>
            <p:cNvPr id="236" name="Rettangolo 235">
              <a:extLst>
                <a:ext uri="{FF2B5EF4-FFF2-40B4-BE49-F238E27FC236}">
                  <a16:creationId xmlns:a16="http://schemas.microsoft.com/office/drawing/2014/main" id="{1B3E3410-AB6E-4EB9-9028-6D4229B5B60A}"/>
                </a:ext>
              </a:extLst>
            </p:cNvPr>
            <p:cNvSpPr/>
            <p:nvPr/>
          </p:nvSpPr>
          <p:spPr>
            <a:xfrm>
              <a:off x="238125" y="2543175"/>
              <a:ext cx="11582400" cy="21691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39" name="Gruppo 238">
            <a:extLst>
              <a:ext uri="{FF2B5EF4-FFF2-40B4-BE49-F238E27FC236}">
                <a16:creationId xmlns:a16="http://schemas.microsoft.com/office/drawing/2014/main" id="{FB9BBC87-7DBF-4D2F-BE4E-2EF9FE895C83}"/>
              </a:ext>
            </a:extLst>
          </p:cNvPr>
          <p:cNvGrpSpPr/>
          <p:nvPr/>
        </p:nvGrpSpPr>
        <p:grpSpPr>
          <a:xfrm>
            <a:off x="238125" y="4855079"/>
            <a:ext cx="11582400" cy="1898146"/>
            <a:chOff x="238125" y="4855079"/>
            <a:chExt cx="11582400" cy="1898146"/>
          </a:xfrm>
        </p:grpSpPr>
        <p:grpSp>
          <p:nvGrpSpPr>
            <p:cNvPr id="227" name="Gruppo 226">
              <a:extLst>
                <a:ext uri="{FF2B5EF4-FFF2-40B4-BE49-F238E27FC236}">
                  <a16:creationId xmlns:a16="http://schemas.microsoft.com/office/drawing/2014/main" id="{F6D0D51E-CED6-4267-A635-D1BA95687B4D}"/>
                </a:ext>
              </a:extLst>
            </p:cNvPr>
            <p:cNvGrpSpPr/>
            <p:nvPr/>
          </p:nvGrpSpPr>
          <p:grpSpPr>
            <a:xfrm>
              <a:off x="1876330" y="4874256"/>
              <a:ext cx="7956450" cy="1703634"/>
              <a:chOff x="2045128" y="4872548"/>
              <a:chExt cx="7956450" cy="1703634"/>
            </a:xfrm>
          </p:grpSpPr>
          <p:grpSp>
            <p:nvGrpSpPr>
              <p:cNvPr id="183" name="Gruppo 182">
                <a:extLst>
                  <a:ext uri="{FF2B5EF4-FFF2-40B4-BE49-F238E27FC236}">
                    <a16:creationId xmlns:a16="http://schemas.microsoft.com/office/drawing/2014/main" id="{20FBAAC7-5F6A-48CC-91CB-524ED962392C}"/>
                  </a:ext>
                </a:extLst>
              </p:cNvPr>
              <p:cNvGrpSpPr/>
              <p:nvPr/>
            </p:nvGrpSpPr>
            <p:grpSpPr>
              <a:xfrm>
                <a:off x="2045128" y="4872548"/>
                <a:ext cx="1403769" cy="1693147"/>
                <a:chOff x="6038994" y="1642337"/>
                <a:chExt cx="1555404" cy="2092576"/>
              </a:xfrm>
            </p:grpSpPr>
            <p:sp>
              <p:nvSpPr>
                <p:cNvPr id="191" name="CasellaDiTesto 190">
                  <a:extLst>
                    <a:ext uri="{FF2B5EF4-FFF2-40B4-BE49-F238E27FC236}">
                      <a16:creationId xmlns:a16="http://schemas.microsoft.com/office/drawing/2014/main" id="{2D6BA6FA-22A7-44AE-BAB8-465369603FE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87531" y="2054055"/>
                  <a:ext cx="506867" cy="2127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5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CasellaDiTesto 191">
                  <a:extLst>
                    <a:ext uri="{FF2B5EF4-FFF2-40B4-BE49-F238E27FC236}">
                      <a16:creationId xmlns:a16="http://schemas.microsoft.com/office/drawing/2014/main" id="{C26B8DC4-DD19-490D-BCEF-7482E4CC135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87530" y="2432890"/>
                  <a:ext cx="506867" cy="2127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100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CasellaDiTesto 192">
                  <a:extLst>
                    <a:ext uri="{FF2B5EF4-FFF2-40B4-BE49-F238E27FC236}">
                      <a16:creationId xmlns:a16="http://schemas.microsoft.com/office/drawing/2014/main" id="{E120A304-3910-4BB2-9E20-1CA0DFA2E22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87529" y="2736915"/>
                  <a:ext cx="506867" cy="2127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5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CasellaDiTesto 193">
                  <a:extLst>
                    <a:ext uri="{FF2B5EF4-FFF2-40B4-BE49-F238E27FC236}">
                      <a16:creationId xmlns:a16="http://schemas.microsoft.com/office/drawing/2014/main" id="{CE69EC7F-8469-44BE-BBFB-8859E09EA10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55154" y="3383216"/>
                  <a:ext cx="506867" cy="2127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it-IT" altLang="it-IT" sz="600" dirty="0" err="1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it-IT" altLang="it-IT" sz="600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95" name="Immagine 194">
                  <a:extLst>
                    <a:ext uri="{FF2B5EF4-FFF2-40B4-BE49-F238E27FC236}">
                      <a16:creationId xmlns:a16="http://schemas.microsoft.com/office/drawing/2014/main" id="{041A72E6-F2E0-4112-8255-B71E46860C3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t="-430"/>
                <a:stretch/>
              </p:blipFill>
              <p:spPr>
                <a:xfrm>
                  <a:off x="6038994" y="1908606"/>
                  <a:ext cx="1048537" cy="1826307"/>
                </a:xfrm>
                <a:prstGeom prst="rect">
                  <a:avLst/>
                </a:prstGeom>
              </p:spPr>
            </p:pic>
            <p:sp>
              <p:nvSpPr>
                <p:cNvPr id="196" name="CasellaDiTesto 100">
                  <a:extLst>
                    <a:ext uri="{FF2B5EF4-FFF2-40B4-BE49-F238E27FC236}">
                      <a16:creationId xmlns:a16="http://schemas.microsoft.com/office/drawing/2014/main" id="{631299AD-BF99-4DC8-8930-2E995036732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265702" y="1642337"/>
                  <a:ext cx="617979" cy="26626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it-IT" altLang="it-IT" sz="800" b="1" dirty="0">
                      <a:latin typeface="Palatino Linotype" panose="02040502050505030304" pitchFamily="18" charset="0"/>
                    </a:rPr>
                    <a:t>FGFR2</a:t>
                  </a:r>
                </a:p>
              </p:txBody>
            </p:sp>
          </p:grpSp>
          <p:grpSp>
            <p:nvGrpSpPr>
              <p:cNvPr id="222" name="Gruppo 221">
                <a:extLst>
                  <a:ext uri="{FF2B5EF4-FFF2-40B4-BE49-F238E27FC236}">
                    <a16:creationId xmlns:a16="http://schemas.microsoft.com/office/drawing/2014/main" id="{0FCC719D-4E77-4C7F-BAF0-2CDDC1B9397C}"/>
                  </a:ext>
                </a:extLst>
              </p:cNvPr>
              <p:cNvGrpSpPr/>
              <p:nvPr/>
            </p:nvGrpSpPr>
            <p:grpSpPr>
              <a:xfrm>
                <a:off x="3731496" y="4927900"/>
                <a:ext cx="1487776" cy="1648282"/>
                <a:chOff x="3206987" y="4866055"/>
                <a:chExt cx="1487776" cy="1648282"/>
              </a:xfrm>
            </p:grpSpPr>
            <p:grpSp>
              <p:nvGrpSpPr>
                <p:cNvPr id="184" name="Gruppo 183">
                  <a:extLst>
                    <a:ext uri="{FF2B5EF4-FFF2-40B4-BE49-F238E27FC236}">
                      <a16:creationId xmlns:a16="http://schemas.microsoft.com/office/drawing/2014/main" id="{FE56F21A-55CB-4C97-812F-C735DFF841AE}"/>
                    </a:ext>
                  </a:extLst>
                </p:cNvPr>
                <p:cNvGrpSpPr/>
                <p:nvPr/>
              </p:nvGrpSpPr>
              <p:grpSpPr>
                <a:xfrm>
                  <a:off x="3206987" y="5067552"/>
                  <a:ext cx="1487776" cy="1446785"/>
                  <a:chOff x="7502331" y="1866216"/>
                  <a:chExt cx="1487776" cy="1446785"/>
                </a:xfrm>
              </p:grpSpPr>
              <p:pic>
                <p:nvPicPr>
                  <p:cNvPr id="186" name="Immagine 185">
                    <a:extLst>
                      <a:ext uri="{FF2B5EF4-FFF2-40B4-BE49-F238E27FC236}">
                        <a16:creationId xmlns:a16="http://schemas.microsoft.com/office/drawing/2014/main" id="{558E6D0F-85D9-4BDB-AAD9-4732E6B30C1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brightnessContrast bright="-20000" contrast="4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502331" y="1866216"/>
                    <a:ext cx="1051375" cy="1446785"/>
                  </a:xfrm>
                  <a:prstGeom prst="rect">
                    <a:avLst/>
                  </a:prstGeom>
                </p:spPr>
              </p:pic>
              <p:sp>
                <p:nvSpPr>
                  <p:cNvPr id="187" name="CasellaDiTesto 186">
                    <a:extLst>
                      <a:ext uri="{FF2B5EF4-FFF2-40B4-BE49-F238E27FC236}">
                        <a16:creationId xmlns:a16="http://schemas.microsoft.com/office/drawing/2014/main" id="{E05E9BA8-745E-4568-A429-339EAD4402E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24487" y="3106102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8" name="CasellaDiTesto 187">
                    <a:extLst>
                      <a:ext uri="{FF2B5EF4-FFF2-40B4-BE49-F238E27FC236}">
                        <a16:creationId xmlns:a16="http://schemas.microsoft.com/office/drawing/2014/main" id="{0C3D3506-5B2E-4A0A-88B6-7374AEFC0C3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32654" y="2543566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9" name="CasellaDiTesto 188">
                    <a:extLst>
                      <a:ext uri="{FF2B5EF4-FFF2-40B4-BE49-F238E27FC236}">
                        <a16:creationId xmlns:a16="http://schemas.microsoft.com/office/drawing/2014/main" id="{464810F1-2C41-4630-9097-82A93B009C1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32654" y="2284099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0" name="CasellaDiTesto 189">
                    <a:extLst>
                      <a:ext uri="{FF2B5EF4-FFF2-40B4-BE49-F238E27FC236}">
                        <a16:creationId xmlns:a16="http://schemas.microsoft.com/office/drawing/2014/main" id="{9A2839B3-285D-44B1-A6FD-865924C8866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524486" y="1992312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85" name="CasellaDiTesto 184">
                  <a:extLst>
                    <a:ext uri="{FF2B5EF4-FFF2-40B4-BE49-F238E27FC236}">
                      <a16:creationId xmlns:a16="http://schemas.microsoft.com/office/drawing/2014/main" id="{77E51744-B1C8-4211-8FF4-6669A3326ABF}"/>
                    </a:ext>
                  </a:extLst>
                </p:cNvPr>
                <p:cNvSpPr txBox="1"/>
                <p:nvPr/>
              </p:nvSpPr>
              <p:spPr>
                <a:xfrm>
                  <a:off x="3420672" y="4866055"/>
                  <a:ext cx="728176" cy="1926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p-FGFR2</a:t>
                  </a:r>
                </a:p>
              </p:txBody>
            </p:sp>
          </p:grpSp>
          <p:grpSp>
            <p:nvGrpSpPr>
              <p:cNvPr id="220" name="Gruppo 219">
                <a:extLst>
                  <a:ext uri="{FF2B5EF4-FFF2-40B4-BE49-F238E27FC236}">
                    <a16:creationId xmlns:a16="http://schemas.microsoft.com/office/drawing/2014/main" id="{B9899111-6C68-49A5-B07B-D52B45E5EED2}"/>
                  </a:ext>
                </a:extLst>
              </p:cNvPr>
              <p:cNvGrpSpPr/>
              <p:nvPr/>
            </p:nvGrpSpPr>
            <p:grpSpPr>
              <a:xfrm>
                <a:off x="7062668" y="4900294"/>
                <a:ext cx="1321359" cy="1675888"/>
                <a:chOff x="6117051" y="4721257"/>
                <a:chExt cx="1321359" cy="1675888"/>
              </a:xfrm>
            </p:grpSpPr>
            <p:grpSp>
              <p:nvGrpSpPr>
                <p:cNvPr id="214" name="Gruppo 213">
                  <a:extLst>
                    <a:ext uri="{FF2B5EF4-FFF2-40B4-BE49-F238E27FC236}">
                      <a16:creationId xmlns:a16="http://schemas.microsoft.com/office/drawing/2014/main" id="{03840553-924C-4AC2-974B-9A77F96E9FDA}"/>
                    </a:ext>
                  </a:extLst>
                </p:cNvPr>
                <p:cNvGrpSpPr/>
                <p:nvPr/>
              </p:nvGrpSpPr>
              <p:grpSpPr>
                <a:xfrm>
                  <a:off x="6117051" y="4925768"/>
                  <a:ext cx="1321359" cy="1471377"/>
                  <a:chOff x="6117051" y="4925768"/>
                  <a:chExt cx="1321359" cy="1471377"/>
                </a:xfrm>
              </p:grpSpPr>
              <p:pic>
                <p:nvPicPr>
                  <p:cNvPr id="198" name="Immagine 197">
                    <a:extLst>
                      <a:ext uri="{FF2B5EF4-FFF2-40B4-BE49-F238E27FC236}">
                        <a16:creationId xmlns:a16="http://schemas.microsoft.com/office/drawing/2014/main" id="{C0987ECA-8772-475C-9081-C22D9E64910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sharpenSoften amount="-27000"/>
                            </a14:imgEffect>
                            <a14:imgEffect>
                              <a14:brightnessContrast contrast="12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6117051" y="4925768"/>
                    <a:ext cx="898143" cy="1471377"/>
                  </a:xfrm>
                  <a:prstGeom prst="rect">
                    <a:avLst/>
                  </a:prstGeom>
                </p:spPr>
              </p:pic>
              <p:sp>
                <p:nvSpPr>
                  <p:cNvPr id="205" name="CasellaDiTesto 204">
                    <a:extLst>
                      <a:ext uri="{FF2B5EF4-FFF2-40B4-BE49-F238E27FC236}">
                        <a16:creationId xmlns:a16="http://schemas.microsoft.com/office/drawing/2014/main" id="{A5451EBC-6A4F-42F9-874E-88E6942E792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80375" y="5056212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6" name="CasellaDiTesto 205">
                    <a:extLst>
                      <a:ext uri="{FF2B5EF4-FFF2-40B4-BE49-F238E27FC236}">
                        <a16:creationId xmlns:a16="http://schemas.microsoft.com/office/drawing/2014/main" id="{B35C99C0-8B4C-4BCC-8B7E-A5472C69485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70514" y="5341386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7" name="CasellaDiTesto 206">
                    <a:extLst>
                      <a:ext uri="{FF2B5EF4-FFF2-40B4-BE49-F238E27FC236}">
                        <a16:creationId xmlns:a16="http://schemas.microsoft.com/office/drawing/2014/main" id="{72B45714-9B4E-4453-87B6-F1A8303B17D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80957" y="5600853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8" name="CasellaDiTesto 207">
                    <a:extLst>
                      <a:ext uri="{FF2B5EF4-FFF2-40B4-BE49-F238E27FC236}">
                        <a16:creationId xmlns:a16="http://schemas.microsoft.com/office/drawing/2014/main" id="{65E7CD3D-C31C-4962-941C-8EE30137574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70513" y="6183927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17" name="CasellaDiTesto 216">
                  <a:extLst>
                    <a:ext uri="{FF2B5EF4-FFF2-40B4-BE49-F238E27FC236}">
                      <a16:creationId xmlns:a16="http://schemas.microsoft.com/office/drawing/2014/main" id="{1E998DBE-95A0-4E85-BF33-88CBC9B10BE2}"/>
                    </a:ext>
                  </a:extLst>
                </p:cNvPr>
                <p:cNvSpPr txBox="1"/>
                <p:nvPr/>
              </p:nvSpPr>
              <p:spPr>
                <a:xfrm>
                  <a:off x="6272984" y="4721257"/>
                  <a:ext cx="1039821" cy="2014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p-FRS2</a:t>
                  </a:r>
                  <a:r>
                    <a:rPr lang="el-GR" altLang="it-IT" sz="8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α</a:t>
                  </a:r>
                  <a:endParaRPr lang="it-IT" sz="800" b="1" dirty="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219" name="Gruppo 218">
                <a:extLst>
                  <a:ext uri="{FF2B5EF4-FFF2-40B4-BE49-F238E27FC236}">
                    <a16:creationId xmlns:a16="http://schemas.microsoft.com/office/drawing/2014/main" id="{70482D2B-43F2-41DA-8A47-63ED588DF762}"/>
                  </a:ext>
                </a:extLst>
              </p:cNvPr>
              <p:cNvGrpSpPr/>
              <p:nvPr/>
            </p:nvGrpSpPr>
            <p:grpSpPr>
              <a:xfrm>
                <a:off x="8748011" y="4876086"/>
                <a:ext cx="1253567" cy="1679897"/>
                <a:chOff x="7898564" y="4597029"/>
                <a:chExt cx="1253567" cy="1679897"/>
              </a:xfrm>
            </p:grpSpPr>
            <p:grpSp>
              <p:nvGrpSpPr>
                <p:cNvPr id="213" name="Gruppo 212">
                  <a:extLst>
                    <a:ext uri="{FF2B5EF4-FFF2-40B4-BE49-F238E27FC236}">
                      <a16:creationId xmlns:a16="http://schemas.microsoft.com/office/drawing/2014/main" id="{0AC6BE9F-BAB6-4E5D-999D-CCA14E96CC6C}"/>
                    </a:ext>
                  </a:extLst>
                </p:cNvPr>
                <p:cNvGrpSpPr/>
                <p:nvPr/>
              </p:nvGrpSpPr>
              <p:grpSpPr>
                <a:xfrm>
                  <a:off x="8684234" y="4970139"/>
                  <a:ext cx="467897" cy="1306787"/>
                  <a:chOff x="8684234" y="4970139"/>
                  <a:chExt cx="467897" cy="1306787"/>
                </a:xfrm>
              </p:grpSpPr>
              <p:sp>
                <p:nvSpPr>
                  <p:cNvPr id="209" name="CasellaDiTesto 208">
                    <a:extLst>
                      <a:ext uri="{FF2B5EF4-FFF2-40B4-BE49-F238E27FC236}">
                        <a16:creationId xmlns:a16="http://schemas.microsoft.com/office/drawing/2014/main" id="{A631CFCA-FF71-4B69-B655-55CC3492C54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94096" y="4970139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0" name="CasellaDiTesto 209">
                    <a:extLst>
                      <a:ext uri="{FF2B5EF4-FFF2-40B4-BE49-F238E27FC236}">
                        <a16:creationId xmlns:a16="http://schemas.microsoft.com/office/drawing/2014/main" id="{6F8FC2A3-63E2-4FEF-8CE8-EED811B06A9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84235" y="5255313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1" name="CasellaDiTesto 210">
                    <a:extLst>
                      <a:ext uri="{FF2B5EF4-FFF2-40B4-BE49-F238E27FC236}">
                        <a16:creationId xmlns:a16="http://schemas.microsoft.com/office/drawing/2014/main" id="{8F12597F-A05D-45C0-A124-900C8AC4284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94678" y="5514780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2" name="CasellaDiTesto 211">
                    <a:extLst>
                      <a:ext uri="{FF2B5EF4-FFF2-40B4-BE49-F238E27FC236}">
                        <a16:creationId xmlns:a16="http://schemas.microsoft.com/office/drawing/2014/main" id="{DE46AF77-AA70-4FA0-AA5B-11D5FF490654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84234" y="6104781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18" name="CasellaDiTesto 217">
                  <a:extLst>
                    <a:ext uri="{FF2B5EF4-FFF2-40B4-BE49-F238E27FC236}">
                      <a16:creationId xmlns:a16="http://schemas.microsoft.com/office/drawing/2014/main" id="{50FBE63A-61E0-4874-A39E-2FD991517BD2}"/>
                    </a:ext>
                  </a:extLst>
                </p:cNvPr>
                <p:cNvSpPr txBox="1"/>
                <p:nvPr/>
              </p:nvSpPr>
              <p:spPr>
                <a:xfrm>
                  <a:off x="7898564" y="4597029"/>
                  <a:ext cx="951239" cy="2043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GADPH</a:t>
                  </a:r>
                </a:p>
              </p:txBody>
            </p:sp>
          </p:grpSp>
          <p:grpSp>
            <p:nvGrpSpPr>
              <p:cNvPr id="221" name="Gruppo 220">
                <a:extLst>
                  <a:ext uri="{FF2B5EF4-FFF2-40B4-BE49-F238E27FC236}">
                    <a16:creationId xmlns:a16="http://schemas.microsoft.com/office/drawing/2014/main" id="{525C3B16-688F-45EF-96FF-6CAF6CB13E70}"/>
                  </a:ext>
                </a:extLst>
              </p:cNvPr>
              <p:cNvGrpSpPr/>
              <p:nvPr/>
            </p:nvGrpSpPr>
            <p:grpSpPr>
              <a:xfrm>
                <a:off x="5708149" y="4920674"/>
                <a:ext cx="1088887" cy="1614810"/>
                <a:chOff x="4502579" y="4732811"/>
                <a:chExt cx="1088887" cy="1614810"/>
              </a:xfrm>
            </p:grpSpPr>
            <p:grpSp>
              <p:nvGrpSpPr>
                <p:cNvPr id="215" name="Gruppo 214">
                  <a:extLst>
                    <a:ext uri="{FF2B5EF4-FFF2-40B4-BE49-F238E27FC236}">
                      <a16:creationId xmlns:a16="http://schemas.microsoft.com/office/drawing/2014/main" id="{70980926-8D2C-42C4-8511-8B319C9F04FC}"/>
                    </a:ext>
                  </a:extLst>
                </p:cNvPr>
                <p:cNvGrpSpPr/>
                <p:nvPr/>
              </p:nvGrpSpPr>
              <p:grpSpPr>
                <a:xfrm>
                  <a:off x="5123569" y="5060738"/>
                  <a:ext cx="467897" cy="1286883"/>
                  <a:chOff x="5123569" y="5060738"/>
                  <a:chExt cx="467897" cy="1286883"/>
                </a:xfrm>
              </p:grpSpPr>
              <p:sp>
                <p:nvSpPr>
                  <p:cNvPr id="201" name="CasellaDiTesto 200">
                    <a:extLst>
                      <a:ext uri="{FF2B5EF4-FFF2-40B4-BE49-F238E27FC236}">
                        <a16:creationId xmlns:a16="http://schemas.microsoft.com/office/drawing/2014/main" id="{402C6CAF-AD39-4190-91E3-12757CF6F5F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33431" y="5060738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5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2" name="CasellaDiTesto 201">
                    <a:extLst>
                      <a:ext uri="{FF2B5EF4-FFF2-40B4-BE49-F238E27FC236}">
                        <a16:creationId xmlns:a16="http://schemas.microsoft.com/office/drawing/2014/main" id="{F09FD715-B9C1-465F-9A78-C85368473C3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23570" y="5345912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100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3" name="CasellaDiTesto 202">
                    <a:extLst>
                      <a:ext uri="{FF2B5EF4-FFF2-40B4-BE49-F238E27FC236}">
                        <a16:creationId xmlns:a16="http://schemas.microsoft.com/office/drawing/2014/main" id="{BB287EB6-CBF8-4B64-85B1-A9CFBA67E06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34013" y="5605379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75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4" name="CasellaDiTesto 203">
                    <a:extLst>
                      <a:ext uri="{FF2B5EF4-FFF2-40B4-BE49-F238E27FC236}">
                        <a16:creationId xmlns:a16="http://schemas.microsoft.com/office/drawing/2014/main" id="{85166C6F-2840-4D10-BD83-973B551B083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123569" y="6175476"/>
                    <a:ext cx="457453" cy="17214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600" dirty="0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37 </a:t>
                    </a:r>
                    <a:r>
                      <a:rPr lang="it-IT" altLang="it-IT" sz="600" dirty="0" err="1">
                        <a:latin typeface="Palatino Linotype" panose="02040502050505030304" pitchFamily="18" charset="0"/>
                        <a:cs typeface="Times New Roman" panose="02020603050405020304" pitchFamily="18" charset="0"/>
                      </a:rPr>
                      <a:t>kDa</a:t>
                    </a:r>
                    <a:endParaRPr lang="it-IT" altLang="it-IT" sz="600" dirty="0">
                      <a:latin typeface="Palatino Linotype" panose="0204050205050503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16" name="CasellaDiTesto 215">
                  <a:extLst>
                    <a:ext uri="{FF2B5EF4-FFF2-40B4-BE49-F238E27FC236}">
                      <a16:creationId xmlns:a16="http://schemas.microsoft.com/office/drawing/2014/main" id="{11B7D5A8-02E6-4E60-B8DD-A6DE07F68A93}"/>
                    </a:ext>
                  </a:extLst>
                </p:cNvPr>
                <p:cNvSpPr txBox="1"/>
                <p:nvPr/>
              </p:nvSpPr>
              <p:spPr>
                <a:xfrm>
                  <a:off x="4502579" y="4732811"/>
                  <a:ext cx="1039821" cy="2014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latin typeface="Palatino Linotype" panose="02040502050505030304" pitchFamily="18" charset="0"/>
                    </a:rPr>
                    <a:t>FRS2</a:t>
                  </a:r>
                  <a:r>
                    <a:rPr lang="el-GR" altLang="it-IT" sz="8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α</a:t>
                  </a:r>
                  <a:endParaRPr lang="it-IT" sz="800" b="1" dirty="0">
                    <a:latin typeface="Palatino Linotype" panose="02040502050505030304" pitchFamily="18" charset="0"/>
                  </a:endParaRPr>
                </a:p>
              </p:txBody>
            </p:sp>
          </p:grpSp>
        </p:grpSp>
        <p:sp>
          <p:nvSpPr>
            <p:cNvPr id="235" name="CasellaDiTesto 234">
              <a:extLst>
                <a:ext uri="{FF2B5EF4-FFF2-40B4-BE49-F238E27FC236}">
                  <a16:creationId xmlns:a16="http://schemas.microsoft.com/office/drawing/2014/main" id="{8250171C-0C52-4A07-90A4-121FC2D35AE8}"/>
                </a:ext>
              </a:extLst>
            </p:cNvPr>
            <p:cNvSpPr txBox="1"/>
            <p:nvPr/>
          </p:nvSpPr>
          <p:spPr>
            <a:xfrm>
              <a:off x="10022314" y="5605910"/>
              <a:ext cx="9366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Figure 5</a:t>
              </a:r>
            </a:p>
          </p:txBody>
        </p:sp>
        <p:sp>
          <p:nvSpPr>
            <p:cNvPr id="238" name="Rettangolo 237">
              <a:extLst>
                <a:ext uri="{FF2B5EF4-FFF2-40B4-BE49-F238E27FC236}">
                  <a16:creationId xmlns:a16="http://schemas.microsoft.com/office/drawing/2014/main" id="{464C8CDB-2A6D-4CEB-AE23-CF2FB9DADC59}"/>
                </a:ext>
              </a:extLst>
            </p:cNvPr>
            <p:cNvSpPr/>
            <p:nvPr/>
          </p:nvSpPr>
          <p:spPr>
            <a:xfrm>
              <a:off x="238125" y="4855079"/>
              <a:ext cx="11582400" cy="18981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pic>
        <p:nvPicPr>
          <p:cNvPr id="2" name="Immagine 1">
            <a:extLst>
              <a:ext uri="{FF2B5EF4-FFF2-40B4-BE49-F238E27FC236}">
                <a16:creationId xmlns:a16="http://schemas.microsoft.com/office/drawing/2014/main" id="{3518B41A-4EA6-43F6-9F42-0569B99171E4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-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819922" y="494949"/>
            <a:ext cx="1859769" cy="1204885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9F9317C6-78BC-4960-90DC-69DE8A02B500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-50000"/>
                    </a14:imgEffect>
                    <a14:imgEffect>
                      <a14:brightnessContrast bright="-20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948357" y="2870135"/>
            <a:ext cx="1304925" cy="160972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C38A5BAD-3701-4ADB-AFB8-FD002DC132F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-50000"/>
                    </a14:imgEffect>
                    <a14:imgEffect>
                      <a14:brightnessContrast bright="-20000" contras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573233" y="5118621"/>
            <a:ext cx="819150" cy="1466850"/>
          </a:xfrm>
          <a:prstGeom prst="rect">
            <a:avLst/>
          </a:prstGeom>
        </p:spPr>
      </p:pic>
      <p:pic>
        <p:nvPicPr>
          <p:cNvPr id="28" name="Immagine 27">
            <a:extLst>
              <a:ext uri="{FF2B5EF4-FFF2-40B4-BE49-F238E27FC236}">
                <a16:creationId xmlns:a16="http://schemas.microsoft.com/office/drawing/2014/main" id="{F49457C4-03BC-49D2-B80B-61166280B08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-58000"/>
                    </a14:imgEffect>
                    <a14:imgEffect>
                      <a14:brightnessContrast contrast="1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16788" y="2922906"/>
            <a:ext cx="1247775" cy="1600200"/>
          </a:xfrm>
          <a:prstGeom prst="rect">
            <a:avLst/>
          </a:prstGeom>
        </p:spPr>
      </p:pic>
      <p:pic>
        <p:nvPicPr>
          <p:cNvPr id="17" name="Immagine 16">
            <a:extLst>
              <a:ext uri="{FF2B5EF4-FFF2-40B4-BE49-F238E27FC236}">
                <a16:creationId xmlns:a16="http://schemas.microsoft.com/office/drawing/2014/main" id="{550226F7-9F5B-4C10-BA60-D643076974C9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-25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57537" y="489143"/>
            <a:ext cx="1742475" cy="1148820"/>
          </a:xfrm>
          <a:prstGeom prst="rect">
            <a:avLst/>
          </a:prstGeom>
        </p:spPr>
      </p:pic>
      <p:sp>
        <p:nvSpPr>
          <p:cNvPr id="144" name="CasellaDiTesto 143">
            <a:extLst>
              <a:ext uri="{FF2B5EF4-FFF2-40B4-BE49-F238E27FC236}">
                <a16:creationId xmlns:a16="http://schemas.microsoft.com/office/drawing/2014/main" id="{CF21CAC2-9763-4380-A89C-55424698B0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64710" y="1459323"/>
            <a:ext cx="462338" cy="17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7 </a:t>
            </a:r>
            <a:r>
              <a:rPr lang="it-IT" altLang="it-IT" sz="6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Immagine 17">
            <a:extLst>
              <a:ext uri="{FF2B5EF4-FFF2-40B4-BE49-F238E27FC236}">
                <a16:creationId xmlns:a16="http://schemas.microsoft.com/office/drawing/2014/main" id="{F979AFEA-05F3-44C7-B005-8BCC46469BE8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t="1887" b="-1"/>
          <a:stretch/>
        </p:blipFill>
        <p:spPr>
          <a:xfrm>
            <a:off x="5242797" y="2885607"/>
            <a:ext cx="1229995" cy="1607461"/>
          </a:xfrm>
          <a:prstGeom prst="rect">
            <a:avLst/>
          </a:prstGeom>
        </p:spPr>
      </p:pic>
      <p:pic>
        <p:nvPicPr>
          <p:cNvPr id="24" name="Immagine 23">
            <a:extLst>
              <a:ext uri="{FF2B5EF4-FFF2-40B4-BE49-F238E27FC236}">
                <a16:creationId xmlns:a16="http://schemas.microsoft.com/office/drawing/2014/main" id="{D50EE587-3898-4D40-929F-8B503B18D090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t="389"/>
          <a:stretch/>
        </p:blipFill>
        <p:spPr>
          <a:xfrm>
            <a:off x="5296209" y="5110018"/>
            <a:ext cx="898143" cy="1492599"/>
          </a:xfrm>
          <a:prstGeom prst="rect">
            <a:avLst/>
          </a:prstGeom>
        </p:spPr>
      </p:pic>
      <p:sp>
        <p:nvSpPr>
          <p:cNvPr id="149" name="CasellaDiTesto 148">
            <a:extLst>
              <a:ext uri="{FF2B5EF4-FFF2-40B4-BE49-F238E27FC236}">
                <a16:creationId xmlns:a16="http://schemas.microsoft.com/office/drawing/2014/main" id="{00430068-4EA4-4DD9-87BF-5B118E9FBA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8663" y="1625699"/>
            <a:ext cx="553550" cy="234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7 </a:t>
            </a:r>
            <a:r>
              <a:rPr lang="it-IT" altLang="it-IT" sz="6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B1A7465C-CA3A-4EC5-B7FA-A2D05A97ED2D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7479527" y="507139"/>
            <a:ext cx="1914525" cy="1175138"/>
          </a:xfrm>
          <a:prstGeom prst="rect">
            <a:avLst/>
          </a:prstGeom>
        </p:spPr>
      </p:pic>
      <p:sp>
        <p:nvSpPr>
          <p:cNvPr id="164" name="CasellaDiTesto 163">
            <a:extLst>
              <a:ext uri="{FF2B5EF4-FFF2-40B4-BE49-F238E27FC236}">
                <a16:creationId xmlns:a16="http://schemas.microsoft.com/office/drawing/2014/main" id="{CE1479E4-38D9-4398-87F1-0410B23CF6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40052" y="1459323"/>
            <a:ext cx="462338" cy="17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it-IT" altLang="it-IT" sz="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37 </a:t>
            </a:r>
            <a:r>
              <a:rPr lang="it-IT" altLang="it-IT" sz="6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kDa</a:t>
            </a:r>
            <a:endParaRPr lang="it-IT" altLang="it-IT" sz="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10DA03B3-2044-4034-8BBA-480863F01E3D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782465" y="503799"/>
            <a:ext cx="1808103" cy="1319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63264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3</TotalTime>
  <Words>167</Words>
  <Application>Microsoft Office PowerPoint</Application>
  <PresentationFormat>Widescreen</PresentationFormat>
  <Paragraphs>8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a Tavolari</dc:creator>
  <cp:lastModifiedBy>Simona Tavolari</cp:lastModifiedBy>
  <cp:revision>77</cp:revision>
  <dcterms:created xsi:type="dcterms:W3CDTF">2023-12-22T11:48:50Z</dcterms:created>
  <dcterms:modified xsi:type="dcterms:W3CDTF">2023-12-28T16:10:57Z</dcterms:modified>
</cp:coreProperties>
</file>